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Zitta, Karina Silvana" initials="ZKS" lastIdx="1" clrIdx="0">
    <p:extLst>
      <p:ext uri="{19B8F6BF-5375-455C-9EA6-DF929625EA0E}">
        <p15:presenceInfo xmlns:p15="http://schemas.microsoft.com/office/powerpoint/2012/main" userId="S-1-5-21-141337351-842245563-3214328492-15731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730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243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C369192-7172-4014-8173-B7E16629DD4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70EB63AF-7946-474D-B8CE-0E2B86FFA62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078FC92-69C1-43A5-A4DA-7AE81DAA44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0CBCF-FCBB-47B0-9C1D-BB7B6CE87541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EEE6FDF-CBC5-4E0F-A947-F2E3A9B197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170C8A3-43A6-4F5B-9DE8-DB06DF7B00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88C904-7822-47D3-94A3-A2AD1D425D6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91775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89E8EBB-74C3-4812-AB97-7725CC1587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BAC2F7F9-2476-4975-BC05-DEFCC53727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FCED913-9CAE-44AD-B3EC-ED1880640A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0CBCF-FCBB-47B0-9C1D-BB7B6CE87541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A7CCE24-FF01-45B0-ABA9-ED12404E6E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EB9B6FA-9A70-4BBE-8577-8498E84F7F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88C904-7822-47D3-94A3-A2AD1D425D6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2611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69A4C297-6850-4A91-97C7-278FDE26EB8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B3FDBD8A-600E-4D70-B721-C3304D94E27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6709219-B9E3-42F9-BB43-ADEAED3DF5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0CBCF-FCBB-47B0-9C1D-BB7B6CE87541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49C6A02-51D3-4409-B1BA-4818264B1E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8DD6ED7-2DAC-4BC7-829E-DA99060B83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88C904-7822-47D3-94A3-A2AD1D425D6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00639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A642CD7-8D12-4A2A-9927-F1611BE403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25EDA0B-1537-41C8-B5FE-D6A0C20E285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106DC8F-3732-4A28-9850-4963EEF0F8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0CBCF-FCBB-47B0-9C1D-BB7B6CE87541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A6A384B-C9ED-4FED-807E-F9CDC58A41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8F5EBD7-4410-4D69-9B87-E1DEA03A10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88C904-7822-47D3-94A3-A2AD1D425D6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77103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BF715C5-06C5-43EC-B264-6FA61EB267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355651F9-8AD7-4C7E-BFF7-C3CAD21BDA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32AD56F-48E2-4381-A4B1-8DA26D29B2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0CBCF-FCBB-47B0-9C1D-BB7B6CE87541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484A343-D516-49AF-B7C8-9E65CB636E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09AC2A0-D24F-49C1-9966-F34DBF2F4D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88C904-7822-47D3-94A3-A2AD1D425D6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37346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104390A-4BC5-446D-83FC-F536625084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A528094-1EE4-4539-B09F-6401F05C960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C6DC5426-B930-4F4C-A764-5C876C8ABF3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BF54D3D2-4BF1-4427-B9F8-EB952AEBAE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0CBCF-FCBB-47B0-9C1D-BB7B6CE87541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26DBD831-5764-4B50-8214-C1BB01150D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981B052B-320B-4DDC-B954-8D25423642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88C904-7822-47D3-94A3-A2AD1D425D6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9525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0024FC8-10AF-44E0-B368-2B624DFE5F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FBE1169-50D6-4089-81FC-A66001B17C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BDAA84BE-307A-40AD-B641-4C2E2851E6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55C40115-D47B-4B4C-BCED-97E4ECC3530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7F1B906E-5E24-4258-AF81-B8B26F41C4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0704CBD9-DAAE-4576-8B03-005C649104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0CBCF-FCBB-47B0-9C1D-BB7B6CE87541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175F8768-93AE-4DE9-BC3C-F48E131243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08D36F7C-7F48-486B-A2AE-5D711B46B5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88C904-7822-47D3-94A3-A2AD1D425D6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96193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AF98EE0-7812-444C-BD2C-141B1F38C4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3076CC0F-AA37-40DA-B3A2-0F37BD793C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0CBCF-FCBB-47B0-9C1D-BB7B6CE87541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4363C728-CAAD-45A2-B07E-5A4B205471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3BA0483E-4922-4027-957F-1D2066DF45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88C904-7822-47D3-94A3-A2AD1D425D6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59699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3777CBA9-2FC4-4E5F-8403-FE4A3C2F06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0CBCF-FCBB-47B0-9C1D-BB7B6CE87541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402A1B77-99DE-4796-97F7-EB873ACF98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ED1F7DA2-E79A-4D83-8496-EEE06FE396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88C904-7822-47D3-94A3-A2AD1D425D6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95172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DD6A50B-9FC5-4044-9927-FA9266C3C5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D2C65B7B-E24B-4D51-9B73-673DA1E4324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180D3808-D467-40AF-8DBC-6205DBB29C7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825A980A-0322-4D1A-89C0-2A3DEB4044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0CBCF-FCBB-47B0-9C1D-BB7B6CE87541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8E4C836-882B-4BAD-B2DF-38AC3700A4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E5362D22-F74D-4713-92D9-383A6070D7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88C904-7822-47D3-94A3-A2AD1D425D6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22228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DFC5F0A-DBB5-464A-B68F-334968D239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8488F3B8-C583-42FB-938A-9DA43FBBD97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108E8BB8-A230-45DD-8D28-1DA5166A38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DF35D323-FF63-46BB-8420-68E993748A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0CBCF-FCBB-47B0-9C1D-BB7B6CE87541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FD5F8A6-1289-43BF-8637-99AB0E273B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F0A81160-6885-4456-934A-1ED610CB26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88C904-7822-47D3-94A3-A2AD1D425D6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1725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F4635E97-6EE5-4239-A369-58891823D2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90F09BCF-9BE6-454F-B4BB-53BF3784F6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D5B1344-DBC4-4292-BD4C-4B6DFFA4E3F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B0CBCF-FCBB-47B0-9C1D-BB7B6CE87541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0D31AD3-0737-4C74-A585-568DF2E0274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7BF52DB-AABF-4A10-B1F2-B70D6C626E2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88C904-7822-47D3-94A3-A2AD1D425D6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54298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pieren 2">
            <a:extLst>
              <a:ext uri="{FF2B5EF4-FFF2-40B4-BE49-F238E27FC236}">
                <a16:creationId xmlns:a16="http://schemas.microsoft.com/office/drawing/2014/main" id="{6743A86D-CACE-4E93-B02E-E4781793B5CE}"/>
              </a:ext>
            </a:extLst>
          </p:cNvPr>
          <p:cNvGrpSpPr/>
          <p:nvPr/>
        </p:nvGrpSpPr>
        <p:grpSpPr>
          <a:xfrm>
            <a:off x="1736555" y="425301"/>
            <a:ext cx="8991696" cy="6013267"/>
            <a:chOff x="1736555" y="425301"/>
            <a:chExt cx="8991696" cy="6013267"/>
          </a:xfrm>
        </p:grpSpPr>
        <p:sp>
          <p:nvSpPr>
            <p:cNvPr id="16" name="Textfeld 15">
              <a:extLst>
                <a:ext uri="{FF2B5EF4-FFF2-40B4-BE49-F238E27FC236}">
                  <a16:creationId xmlns:a16="http://schemas.microsoft.com/office/drawing/2014/main" id="{01CF36A1-E6D8-4298-A52C-711DE270E2FB}"/>
                </a:ext>
              </a:extLst>
            </p:cNvPr>
            <p:cNvSpPr txBox="1"/>
            <p:nvPr/>
          </p:nvSpPr>
          <p:spPr>
            <a:xfrm>
              <a:off x="1736555" y="5976903"/>
              <a:ext cx="895903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l Figure S2: Representative flow cytometry for vesicular biomarkers.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. Gating of L-EV</a:t>
              </a:r>
              <a:r>
                <a:rPr lang="en-US" sz="12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reg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light blue) and Mreg (red). B. Analysis of L-EV</a:t>
              </a:r>
              <a:r>
                <a:rPr lang="en-US" sz="12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reg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r the surface expression of LAMP-1, CD9, CD63 and CD81. FSC, forward scatter; SSC, sideward scatter.</a:t>
              </a:r>
            </a:p>
          </p:txBody>
        </p:sp>
        <p:sp>
          <p:nvSpPr>
            <p:cNvPr id="58" name="Rechteck 57">
              <a:extLst>
                <a:ext uri="{FF2B5EF4-FFF2-40B4-BE49-F238E27FC236}">
                  <a16:creationId xmlns:a16="http://schemas.microsoft.com/office/drawing/2014/main" id="{229B9039-C2D3-493E-BFCB-FA731DE92763}"/>
                </a:ext>
              </a:extLst>
            </p:cNvPr>
            <p:cNvSpPr/>
            <p:nvPr/>
          </p:nvSpPr>
          <p:spPr>
            <a:xfrm>
              <a:off x="1807535" y="425301"/>
              <a:ext cx="8920716" cy="5551602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4" name="Gruppieren 3">
              <a:extLst>
                <a:ext uri="{FF2B5EF4-FFF2-40B4-BE49-F238E27FC236}">
                  <a16:creationId xmlns:a16="http://schemas.microsoft.com/office/drawing/2014/main" id="{82785F3F-031A-4F57-B174-13A589CADF20}"/>
                </a:ext>
              </a:extLst>
            </p:cNvPr>
            <p:cNvGrpSpPr/>
            <p:nvPr/>
          </p:nvGrpSpPr>
          <p:grpSpPr>
            <a:xfrm>
              <a:off x="5509326" y="491766"/>
              <a:ext cx="2529977" cy="2575973"/>
              <a:chOff x="5509326" y="429172"/>
              <a:chExt cx="2529977" cy="2575973"/>
            </a:xfrm>
          </p:grpSpPr>
          <p:grpSp>
            <p:nvGrpSpPr>
              <p:cNvPr id="45" name="Gruppieren 44">
                <a:extLst>
                  <a:ext uri="{FF2B5EF4-FFF2-40B4-BE49-F238E27FC236}">
                    <a16:creationId xmlns:a16="http://schemas.microsoft.com/office/drawing/2014/main" id="{71A657DF-36F2-4C09-9827-C24CE901489E}"/>
                  </a:ext>
                </a:extLst>
              </p:cNvPr>
              <p:cNvGrpSpPr/>
              <p:nvPr/>
            </p:nvGrpSpPr>
            <p:grpSpPr>
              <a:xfrm>
                <a:off x="5509326" y="650180"/>
                <a:ext cx="2469943" cy="2354965"/>
                <a:chOff x="3895472" y="3312169"/>
                <a:chExt cx="2469943" cy="2354965"/>
              </a:xfrm>
            </p:grpSpPr>
            <p:pic>
              <p:nvPicPr>
                <p:cNvPr id="6" name="Grafik 5">
                  <a:extLst>
                    <a:ext uri="{FF2B5EF4-FFF2-40B4-BE49-F238E27FC236}">
                      <a16:creationId xmlns:a16="http://schemas.microsoft.com/office/drawing/2014/main" id="{BA1208A4-B582-4470-B063-92BF196252D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5766" t="6189" r="14613" b="36985"/>
                <a:stretch/>
              </p:blipFill>
              <p:spPr>
                <a:xfrm>
                  <a:off x="4042718" y="3312169"/>
                  <a:ext cx="2322697" cy="2199805"/>
                </a:xfrm>
                <a:prstGeom prst="rect">
                  <a:avLst/>
                </a:prstGeom>
              </p:spPr>
            </p:pic>
            <p:sp>
              <p:nvSpPr>
                <p:cNvPr id="25" name="Textfeld 24">
                  <a:extLst>
                    <a:ext uri="{FF2B5EF4-FFF2-40B4-BE49-F238E27FC236}">
                      <a16:creationId xmlns:a16="http://schemas.microsoft.com/office/drawing/2014/main" id="{2B373E77-A62D-4437-BE83-F002BD29C8FB}"/>
                    </a:ext>
                  </a:extLst>
                </p:cNvPr>
                <p:cNvSpPr txBox="1"/>
                <p:nvPr/>
              </p:nvSpPr>
              <p:spPr>
                <a:xfrm rot="16200000">
                  <a:off x="3281522" y="4292863"/>
                  <a:ext cx="1489510" cy="26161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Fluorescence intensity</a:t>
                  </a:r>
                </a:p>
              </p:txBody>
            </p:sp>
            <p:sp>
              <p:nvSpPr>
                <p:cNvPr id="26" name="Textfeld 25">
                  <a:extLst>
                    <a:ext uri="{FF2B5EF4-FFF2-40B4-BE49-F238E27FC236}">
                      <a16:creationId xmlns:a16="http://schemas.microsoft.com/office/drawing/2014/main" id="{D19D9A3F-3EA6-4A6D-BA4B-AAD0DE0C4FBD}"/>
                    </a:ext>
                  </a:extLst>
                </p:cNvPr>
                <p:cNvSpPr txBox="1"/>
                <p:nvPr/>
              </p:nvSpPr>
              <p:spPr>
                <a:xfrm>
                  <a:off x="5108458" y="5405524"/>
                  <a:ext cx="391454" cy="26161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1100" b="1" dirty="0"/>
                    <a:t>FSC</a:t>
                  </a:r>
                  <a:endParaRPr lang="en-US" sz="1100" b="1" dirty="0"/>
                </a:p>
              </p:txBody>
            </p:sp>
            <p:sp>
              <p:nvSpPr>
                <p:cNvPr id="31" name="Textfeld 30">
                  <a:extLst>
                    <a:ext uri="{FF2B5EF4-FFF2-40B4-BE49-F238E27FC236}">
                      <a16:creationId xmlns:a16="http://schemas.microsoft.com/office/drawing/2014/main" id="{1A11B4AE-DE60-4448-B0EA-7464D7FC5A10}"/>
                    </a:ext>
                  </a:extLst>
                </p:cNvPr>
                <p:cNvSpPr txBox="1"/>
                <p:nvPr/>
              </p:nvSpPr>
              <p:spPr>
                <a:xfrm>
                  <a:off x="5218008" y="3353231"/>
                  <a:ext cx="1053494" cy="26161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1100" dirty="0">
                      <a:solidFill>
                        <a:srgbClr val="0000FF"/>
                      </a:solidFill>
                    </a:rPr>
                    <a:t>Positive: 54.9%</a:t>
                  </a:r>
                  <a:endParaRPr lang="en-US" sz="1100" dirty="0">
                    <a:solidFill>
                      <a:srgbClr val="0000FF"/>
                    </a:solidFill>
                  </a:endParaRPr>
                </a:p>
              </p:txBody>
            </p:sp>
          </p:grpSp>
          <p:sp>
            <p:nvSpPr>
              <p:cNvPr id="33" name="Textfeld 32">
                <a:extLst>
                  <a:ext uri="{FF2B5EF4-FFF2-40B4-BE49-F238E27FC236}">
                    <a16:creationId xmlns:a16="http://schemas.microsoft.com/office/drawing/2014/main" id="{1F25A5C0-6592-460E-AF42-B399599F13A9}"/>
                  </a:ext>
                </a:extLst>
              </p:cNvPr>
              <p:cNvSpPr txBox="1"/>
              <p:nvPr/>
            </p:nvSpPr>
            <p:spPr>
              <a:xfrm>
                <a:off x="5819059" y="429172"/>
                <a:ext cx="2220244" cy="21620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100" b="1" dirty="0"/>
                  <a:t>LAMP-1</a:t>
                </a:r>
                <a:endParaRPr lang="en-US" sz="1100" b="1" dirty="0"/>
              </a:p>
            </p:txBody>
          </p:sp>
        </p:grpSp>
        <p:grpSp>
          <p:nvGrpSpPr>
            <p:cNvPr id="13" name="Gruppieren 12">
              <a:extLst>
                <a:ext uri="{FF2B5EF4-FFF2-40B4-BE49-F238E27FC236}">
                  <a16:creationId xmlns:a16="http://schemas.microsoft.com/office/drawing/2014/main" id="{3391374E-5356-4CF7-9630-FF168F295176}"/>
                </a:ext>
              </a:extLst>
            </p:cNvPr>
            <p:cNvGrpSpPr/>
            <p:nvPr/>
          </p:nvGrpSpPr>
          <p:grpSpPr>
            <a:xfrm>
              <a:off x="8060527" y="520191"/>
              <a:ext cx="2461881" cy="2604638"/>
              <a:chOff x="8060527" y="448072"/>
              <a:chExt cx="2461881" cy="2604638"/>
            </a:xfrm>
          </p:grpSpPr>
          <p:pic>
            <p:nvPicPr>
              <p:cNvPr id="7" name="Grafik 6">
                <a:extLst>
                  <a:ext uri="{FF2B5EF4-FFF2-40B4-BE49-F238E27FC236}">
                    <a16:creationId xmlns:a16="http://schemas.microsoft.com/office/drawing/2014/main" id="{F7841D38-8AB7-4832-BC3D-06859C22909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9484" t="6376" r="15639" b="38781"/>
              <a:stretch/>
            </p:blipFill>
            <p:spPr>
              <a:xfrm>
                <a:off x="8338099" y="653512"/>
                <a:ext cx="2184309" cy="2123092"/>
              </a:xfrm>
              <a:prstGeom prst="rect">
                <a:avLst/>
              </a:prstGeom>
            </p:spPr>
          </p:pic>
          <p:sp>
            <p:nvSpPr>
              <p:cNvPr id="24" name="Textfeld 23">
                <a:extLst>
                  <a:ext uri="{FF2B5EF4-FFF2-40B4-BE49-F238E27FC236}">
                    <a16:creationId xmlns:a16="http://schemas.microsoft.com/office/drawing/2014/main" id="{6D15A224-FEF1-4E5A-8B40-336D53480B43}"/>
                  </a:ext>
                </a:extLst>
              </p:cNvPr>
              <p:cNvSpPr txBox="1"/>
              <p:nvPr/>
            </p:nvSpPr>
            <p:spPr>
              <a:xfrm>
                <a:off x="9295286" y="2791100"/>
                <a:ext cx="391454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de-DE" sz="1100" b="1" dirty="0"/>
                  <a:t>FSC</a:t>
                </a:r>
                <a:endParaRPr lang="en-US" sz="1100" b="1" dirty="0"/>
              </a:p>
            </p:txBody>
          </p:sp>
          <p:sp>
            <p:nvSpPr>
              <p:cNvPr id="17" name="Textfeld 16">
                <a:extLst>
                  <a:ext uri="{FF2B5EF4-FFF2-40B4-BE49-F238E27FC236}">
                    <a16:creationId xmlns:a16="http://schemas.microsoft.com/office/drawing/2014/main" id="{55AF1CC3-A78A-461F-97DC-F24D62819E66}"/>
                  </a:ext>
                </a:extLst>
              </p:cNvPr>
              <p:cNvSpPr txBox="1"/>
              <p:nvPr/>
            </p:nvSpPr>
            <p:spPr>
              <a:xfrm>
                <a:off x="9381248" y="681242"/>
                <a:ext cx="1053494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de-DE" sz="1100" dirty="0">
                    <a:solidFill>
                      <a:srgbClr val="0000FF"/>
                    </a:solidFill>
                  </a:rPr>
                  <a:t>Positive: 47.5%</a:t>
                </a:r>
                <a:endParaRPr lang="en-US" sz="1100" dirty="0">
                  <a:solidFill>
                    <a:srgbClr val="0000FF"/>
                  </a:solidFill>
                </a:endParaRPr>
              </a:p>
            </p:txBody>
          </p:sp>
          <p:sp>
            <p:nvSpPr>
              <p:cNvPr id="34" name="Textfeld 33">
                <a:extLst>
                  <a:ext uri="{FF2B5EF4-FFF2-40B4-BE49-F238E27FC236}">
                    <a16:creationId xmlns:a16="http://schemas.microsoft.com/office/drawing/2014/main" id="{8C3A4042-6975-460C-9F00-D53576137628}"/>
                  </a:ext>
                </a:extLst>
              </p:cNvPr>
              <p:cNvSpPr txBox="1"/>
              <p:nvPr/>
            </p:nvSpPr>
            <p:spPr>
              <a:xfrm>
                <a:off x="8356275" y="448072"/>
                <a:ext cx="2124434" cy="19655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100" b="1" dirty="0"/>
                  <a:t>CD9</a:t>
                </a:r>
                <a:endParaRPr lang="en-US" sz="1100" b="1" dirty="0"/>
              </a:p>
            </p:txBody>
          </p:sp>
          <p:sp>
            <p:nvSpPr>
              <p:cNvPr id="36" name="Textfeld 35">
                <a:extLst>
                  <a:ext uri="{FF2B5EF4-FFF2-40B4-BE49-F238E27FC236}">
                    <a16:creationId xmlns:a16="http://schemas.microsoft.com/office/drawing/2014/main" id="{CDFDAD39-BF4A-42FE-9DB0-9F69CA0BA81C}"/>
                  </a:ext>
                </a:extLst>
              </p:cNvPr>
              <p:cNvSpPr txBox="1"/>
              <p:nvPr/>
            </p:nvSpPr>
            <p:spPr>
              <a:xfrm rot="16200000">
                <a:off x="7385612" y="1612826"/>
                <a:ext cx="1611440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/>
                  <a:t>Fluorescence intensity</a:t>
                </a:r>
              </a:p>
            </p:txBody>
          </p:sp>
        </p:grpSp>
        <p:grpSp>
          <p:nvGrpSpPr>
            <p:cNvPr id="2" name="Gruppieren 1">
              <a:extLst>
                <a:ext uri="{FF2B5EF4-FFF2-40B4-BE49-F238E27FC236}">
                  <a16:creationId xmlns:a16="http://schemas.microsoft.com/office/drawing/2014/main" id="{5B3FB110-3476-4817-8D32-C573D901AAEE}"/>
                </a:ext>
              </a:extLst>
            </p:cNvPr>
            <p:cNvGrpSpPr/>
            <p:nvPr/>
          </p:nvGrpSpPr>
          <p:grpSpPr>
            <a:xfrm>
              <a:off x="8055790" y="3196516"/>
              <a:ext cx="2533447" cy="2571296"/>
              <a:chOff x="8055790" y="3027727"/>
              <a:chExt cx="2533447" cy="2571296"/>
            </a:xfrm>
          </p:grpSpPr>
          <p:grpSp>
            <p:nvGrpSpPr>
              <p:cNvPr id="54" name="Gruppieren 53">
                <a:extLst>
                  <a:ext uri="{FF2B5EF4-FFF2-40B4-BE49-F238E27FC236}">
                    <a16:creationId xmlns:a16="http://schemas.microsoft.com/office/drawing/2014/main" id="{0F3BC342-5A2A-4A00-A6B8-2FB18F4AC949}"/>
                  </a:ext>
                </a:extLst>
              </p:cNvPr>
              <p:cNvGrpSpPr/>
              <p:nvPr/>
            </p:nvGrpSpPr>
            <p:grpSpPr>
              <a:xfrm>
                <a:off x="8128651" y="3217446"/>
                <a:ext cx="2460586" cy="2381577"/>
                <a:chOff x="8998022" y="829515"/>
                <a:chExt cx="2460586" cy="2381577"/>
              </a:xfrm>
            </p:grpSpPr>
            <p:pic>
              <p:nvPicPr>
                <p:cNvPr id="53" name="Grafik 52">
                  <a:extLst>
                    <a:ext uri="{FF2B5EF4-FFF2-40B4-BE49-F238E27FC236}">
                      <a16:creationId xmlns:a16="http://schemas.microsoft.com/office/drawing/2014/main" id="{5D830269-5203-401A-A226-1C34C296685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3345" t="6169" r="12306" b="36916"/>
                <a:stretch/>
              </p:blipFill>
              <p:spPr>
                <a:xfrm>
                  <a:off x="8998022" y="829515"/>
                  <a:ext cx="2460586" cy="2203287"/>
                </a:xfrm>
                <a:prstGeom prst="rect">
                  <a:avLst/>
                </a:prstGeom>
              </p:spPr>
            </p:pic>
            <p:sp>
              <p:nvSpPr>
                <p:cNvPr id="30" name="Textfeld 29">
                  <a:extLst>
                    <a:ext uri="{FF2B5EF4-FFF2-40B4-BE49-F238E27FC236}">
                      <a16:creationId xmlns:a16="http://schemas.microsoft.com/office/drawing/2014/main" id="{1196207F-A6BA-4CE0-AC06-B35987265007}"/>
                    </a:ext>
                  </a:extLst>
                </p:cNvPr>
                <p:cNvSpPr txBox="1"/>
                <p:nvPr/>
              </p:nvSpPr>
              <p:spPr>
                <a:xfrm>
                  <a:off x="10135568" y="2949482"/>
                  <a:ext cx="391454" cy="26161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1100" b="1" dirty="0"/>
                    <a:t>FSC</a:t>
                  </a:r>
                  <a:endParaRPr lang="en-US" sz="1100" b="1" dirty="0"/>
                </a:p>
              </p:txBody>
            </p:sp>
            <p:sp>
              <p:nvSpPr>
                <p:cNvPr id="42" name="Textfeld 41">
                  <a:extLst>
                    <a:ext uri="{FF2B5EF4-FFF2-40B4-BE49-F238E27FC236}">
                      <a16:creationId xmlns:a16="http://schemas.microsoft.com/office/drawing/2014/main" id="{F404F8C9-E32D-4952-A33C-B2E2F79231AB}"/>
                    </a:ext>
                  </a:extLst>
                </p:cNvPr>
                <p:cNvSpPr txBox="1"/>
                <p:nvPr/>
              </p:nvSpPr>
              <p:spPr>
                <a:xfrm>
                  <a:off x="10231711" y="871154"/>
                  <a:ext cx="1053494" cy="26161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1100" dirty="0">
                      <a:solidFill>
                        <a:srgbClr val="0000FF"/>
                      </a:solidFill>
                    </a:rPr>
                    <a:t>Positive: 62.3%</a:t>
                  </a:r>
                  <a:endParaRPr lang="en-US" sz="1100" dirty="0">
                    <a:solidFill>
                      <a:srgbClr val="0000FF"/>
                    </a:solidFill>
                  </a:endParaRPr>
                </a:p>
              </p:txBody>
            </p:sp>
          </p:grpSp>
          <p:sp>
            <p:nvSpPr>
              <p:cNvPr id="35" name="Textfeld 34">
                <a:extLst>
                  <a:ext uri="{FF2B5EF4-FFF2-40B4-BE49-F238E27FC236}">
                    <a16:creationId xmlns:a16="http://schemas.microsoft.com/office/drawing/2014/main" id="{8A2D3E21-076B-4D9C-894E-87120D425431}"/>
                  </a:ext>
                </a:extLst>
              </p:cNvPr>
              <p:cNvSpPr txBox="1"/>
              <p:nvPr/>
            </p:nvSpPr>
            <p:spPr>
              <a:xfrm>
                <a:off x="8456242" y="3027727"/>
                <a:ext cx="1997290" cy="19655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100" b="1" dirty="0"/>
                  <a:t>CD81</a:t>
                </a:r>
                <a:endParaRPr lang="en-US" sz="1100" b="1" dirty="0"/>
              </a:p>
            </p:txBody>
          </p:sp>
          <p:sp>
            <p:nvSpPr>
              <p:cNvPr id="37" name="Textfeld 36">
                <a:extLst>
                  <a:ext uri="{FF2B5EF4-FFF2-40B4-BE49-F238E27FC236}">
                    <a16:creationId xmlns:a16="http://schemas.microsoft.com/office/drawing/2014/main" id="{DB928646-7393-4039-B70B-2C61D908BFCF}"/>
                  </a:ext>
                </a:extLst>
              </p:cNvPr>
              <p:cNvSpPr txBox="1"/>
              <p:nvPr/>
            </p:nvSpPr>
            <p:spPr>
              <a:xfrm rot="16200000">
                <a:off x="7380875" y="4203501"/>
                <a:ext cx="1611440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/>
                  <a:t>Fluorescence intensity</a:t>
                </a:r>
              </a:p>
            </p:txBody>
          </p:sp>
        </p:grpSp>
        <p:grpSp>
          <p:nvGrpSpPr>
            <p:cNvPr id="12" name="Gruppieren 11">
              <a:extLst>
                <a:ext uri="{FF2B5EF4-FFF2-40B4-BE49-F238E27FC236}">
                  <a16:creationId xmlns:a16="http://schemas.microsoft.com/office/drawing/2014/main" id="{46D6F421-55EF-4EE7-824C-33A75362207F}"/>
                </a:ext>
              </a:extLst>
            </p:cNvPr>
            <p:cNvGrpSpPr/>
            <p:nvPr/>
          </p:nvGrpSpPr>
          <p:grpSpPr>
            <a:xfrm>
              <a:off x="1895602" y="1393898"/>
              <a:ext cx="3500847" cy="3380680"/>
              <a:chOff x="1895602" y="1208841"/>
              <a:chExt cx="3500847" cy="3380680"/>
            </a:xfrm>
          </p:grpSpPr>
          <p:grpSp>
            <p:nvGrpSpPr>
              <p:cNvPr id="10" name="Gruppieren 9">
                <a:extLst>
                  <a:ext uri="{FF2B5EF4-FFF2-40B4-BE49-F238E27FC236}">
                    <a16:creationId xmlns:a16="http://schemas.microsoft.com/office/drawing/2014/main" id="{CE86F1AE-4936-4E1B-B881-E125B468887C}"/>
                  </a:ext>
                </a:extLst>
              </p:cNvPr>
              <p:cNvGrpSpPr/>
              <p:nvPr/>
            </p:nvGrpSpPr>
            <p:grpSpPr>
              <a:xfrm>
                <a:off x="1895602" y="1208841"/>
                <a:ext cx="3500847" cy="3380680"/>
                <a:chOff x="1895602" y="1208841"/>
                <a:chExt cx="3500847" cy="3380680"/>
              </a:xfrm>
            </p:grpSpPr>
            <p:grpSp>
              <p:nvGrpSpPr>
                <p:cNvPr id="57" name="Gruppieren 56">
                  <a:extLst>
                    <a:ext uri="{FF2B5EF4-FFF2-40B4-BE49-F238E27FC236}">
                      <a16:creationId xmlns:a16="http://schemas.microsoft.com/office/drawing/2014/main" id="{AEBB6D36-A459-4C68-9022-D6E649B0198F}"/>
                    </a:ext>
                  </a:extLst>
                </p:cNvPr>
                <p:cNvGrpSpPr/>
                <p:nvPr/>
              </p:nvGrpSpPr>
              <p:grpSpPr>
                <a:xfrm>
                  <a:off x="1895602" y="1208841"/>
                  <a:ext cx="3500847" cy="3380680"/>
                  <a:chOff x="545267" y="1421492"/>
                  <a:chExt cx="3500847" cy="3380680"/>
                </a:xfrm>
              </p:grpSpPr>
              <p:pic>
                <p:nvPicPr>
                  <p:cNvPr id="56" name="Grafik 55">
                    <a:extLst>
                      <a:ext uri="{FF2B5EF4-FFF2-40B4-BE49-F238E27FC236}">
                        <a16:creationId xmlns:a16="http://schemas.microsoft.com/office/drawing/2014/main" id="{FD03DB92-A5AD-4DEE-B8F8-7153BDFC200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5"/>
                  <a:srcRect l="4668" t="6356" r="14655" b="36280"/>
                  <a:stretch/>
                </p:blipFill>
                <p:spPr>
                  <a:xfrm>
                    <a:off x="600428" y="1421492"/>
                    <a:ext cx="3445686" cy="3251277"/>
                  </a:xfrm>
                  <a:prstGeom prst="rect">
                    <a:avLst/>
                  </a:prstGeom>
                </p:spPr>
              </p:pic>
              <p:sp>
                <p:nvSpPr>
                  <p:cNvPr id="39" name="Textfeld 38">
                    <a:extLst>
                      <a:ext uri="{FF2B5EF4-FFF2-40B4-BE49-F238E27FC236}">
                        <a16:creationId xmlns:a16="http://schemas.microsoft.com/office/drawing/2014/main" id="{F03D8539-1266-4C20-B43B-CAB9C8785944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478742" y="2783312"/>
                    <a:ext cx="394660" cy="261610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1100" b="1" dirty="0"/>
                      <a:t>SSC</a:t>
                    </a:r>
                    <a:endParaRPr lang="en-US" sz="1100" b="1" dirty="0"/>
                  </a:p>
                </p:txBody>
              </p:sp>
              <p:sp>
                <p:nvSpPr>
                  <p:cNvPr id="40" name="Textfeld 39">
                    <a:extLst>
                      <a:ext uri="{FF2B5EF4-FFF2-40B4-BE49-F238E27FC236}">
                        <a16:creationId xmlns:a16="http://schemas.microsoft.com/office/drawing/2014/main" id="{18D58D3B-DE0F-4475-91E4-1058EF8B148E}"/>
                      </a:ext>
                    </a:extLst>
                  </p:cNvPr>
                  <p:cNvSpPr txBox="1"/>
                  <p:nvPr/>
                </p:nvSpPr>
                <p:spPr>
                  <a:xfrm>
                    <a:off x="2293163" y="4540562"/>
                    <a:ext cx="323515" cy="261610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1100" b="1" dirty="0"/>
                      <a:t>FSC</a:t>
                    </a:r>
                    <a:endParaRPr lang="en-US" sz="1100" b="1" dirty="0"/>
                  </a:p>
                </p:txBody>
              </p:sp>
            </p:grpSp>
            <p:sp>
              <p:nvSpPr>
                <p:cNvPr id="41" name="Textfeld 40">
                  <a:extLst>
                    <a:ext uri="{FF2B5EF4-FFF2-40B4-BE49-F238E27FC236}">
                      <a16:creationId xmlns:a16="http://schemas.microsoft.com/office/drawing/2014/main" id="{34D1A93E-B749-4D45-BB30-00182F0477B0}"/>
                    </a:ext>
                  </a:extLst>
                </p:cNvPr>
                <p:cNvSpPr txBox="1"/>
                <p:nvPr/>
              </p:nvSpPr>
              <p:spPr>
                <a:xfrm>
                  <a:off x="4485047" y="1885200"/>
                  <a:ext cx="633771" cy="297259"/>
                </a:xfrm>
                <a:prstGeom prst="rect">
                  <a:avLst/>
                </a:prstGeom>
                <a:solidFill>
                  <a:schemeClr val="bg1"/>
                </a:solidFill>
                <a:ln w="12700" cap="flat">
                  <a:noFill/>
                  <a:miter lim="400000"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37147" tIns="37147" rIns="37147" bIns="37147" numCol="1" spcCol="38100" rtlCol="0" anchor="t">
                  <a:spAutoFit/>
                </a:bodyPr>
                <a:lstStyle/>
                <a:p>
                  <a:pPr algn="ctr" defTabSz="742927" hangingPunct="0"/>
                  <a:r>
                    <a:rPr lang="de-DE" sz="1444" b="1" dirty="0" err="1">
                      <a:solidFill>
                        <a:srgbClr val="000080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Mreg</a:t>
                  </a:r>
                  <a:endParaRPr lang="es-AR" sz="1444" b="1" dirty="0">
                    <a:solidFill>
                      <a:srgbClr val="000080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</p:grpSp>
          <p:sp>
            <p:nvSpPr>
              <p:cNvPr id="11" name="Rechteck 10">
                <a:extLst>
                  <a:ext uri="{FF2B5EF4-FFF2-40B4-BE49-F238E27FC236}">
                    <a16:creationId xmlns:a16="http://schemas.microsoft.com/office/drawing/2014/main" id="{CCE7E550-606A-4F08-9C5A-67F85F590ED7}"/>
                  </a:ext>
                </a:extLst>
              </p:cNvPr>
              <p:cNvSpPr/>
              <p:nvPr/>
            </p:nvSpPr>
            <p:spPr>
              <a:xfrm>
                <a:off x="2390115" y="2898796"/>
                <a:ext cx="529941" cy="17032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7" name="Textfeld 46">
                <a:extLst>
                  <a:ext uri="{FF2B5EF4-FFF2-40B4-BE49-F238E27FC236}">
                    <a16:creationId xmlns:a16="http://schemas.microsoft.com/office/drawing/2014/main" id="{0DC0AD59-10C3-43F2-A31C-61E845CFA1AB}"/>
                  </a:ext>
                </a:extLst>
              </p:cNvPr>
              <p:cNvSpPr txBox="1"/>
              <p:nvPr/>
            </p:nvSpPr>
            <p:spPr>
              <a:xfrm>
                <a:off x="2433531" y="2816373"/>
                <a:ext cx="805063" cy="297259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sp3d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square" lIns="37147" tIns="37147" rIns="37147" bIns="37147" numCol="1" spcCol="38100" rtlCol="0" anchor="t">
                <a:spAutoFit/>
              </a:bodyPr>
              <a:lstStyle/>
              <a:p>
                <a:pPr defTabSz="742927" hangingPunct="0"/>
                <a:r>
                  <a:rPr lang="de-DE" sz="1444" b="1" dirty="0">
                    <a:solidFill>
                      <a:srgbClr val="005A00"/>
                    </a:solidFill>
                    <a:latin typeface="Arial"/>
                    <a:ea typeface="Arial"/>
                    <a:cs typeface="Arial"/>
                    <a:sym typeface="Arial"/>
                  </a:rPr>
                  <a:t>L-</a:t>
                </a:r>
                <a:r>
                  <a:rPr lang="de-DE" sz="1444" b="1" dirty="0" err="1">
                    <a:solidFill>
                      <a:srgbClr val="005A00"/>
                    </a:solidFill>
                    <a:latin typeface="Arial"/>
                    <a:ea typeface="Arial"/>
                    <a:cs typeface="Arial"/>
                    <a:sym typeface="Arial"/>
                  </a:rPr>
                  <a:t>EV</a:t>
                </a:r>
                <a:r>
                  <a:rPr lang="de-DE" sz="1444" b="1" baseline="-25000" dirty="0" err="1">
                    <a:solidFill>
                      <a:srgbClr val="005A00"/>
                    </a:solidFill>
                    <a:latin typeface="Arial"/>
                    <a:ea typeface="Arial"/>
                    <a:cs typeface="Arial"/>
                    <a:sym typeface="Arial"/>
                  </a:rPr>
                  <a:t>Mreg</a:t>
                </a:r>
                <a:endParaRPr lang="es-AR" sz="1444" b="1" baseline="-25000" dirty="0">
                  <a:solidFill>
                    <a:srgbClr val="005A00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</p:grpSp>
        <p:grpSp>
          <p:nvGrpSpPr>
            <p:cNvPr id="15" name="Gruppieren 14">
              <a:extLst>
                <a:ext uri="{FF2B5EF4-FFF2-40B4-BE49-F238E27FC236}">
                  <a16:creationId xmlns:a16="http://schemas.microsoft.com/office/drawing/2014/main" id="{7F00B1D0-033C-4244-888B-9BF3B842B661}"/>
                </a:ext>
              </a:extLst>
            </p:cNvPr>
            <p:cNvGrpSpPr/>
            <p:nvPr/>
          </p:nvGrpSpPr>
          <p:grpSpPr>
            <a:xfrm>
              <a:off x="5542022" y="3173598"/>
              <a:ext cx="2458948" cy="2547532"/>
              <a:chOff x="5542022" y="2977650"/>
              <a:chExt cx="2458948" cy="2547532"/>
            </a:xfrm>
          </p:grpSpPr>
          <p:pic>
            <p:nvPicPr>
              <p:cNvPr id="14" name="Grafik 13">
                <a:extLst>
                  <a:ext uri="{FF2B5EF4-FFF2-40B4-BE49-F238E27FC236}">
                    <a16:creationId xmlns:a16="http://schemas.microsoft.com/office/drawing/2014/main" id="{12FD43E1-2924-4745-B9C0-5D489ACCE5D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8729" t="6111" r="14768" b="38780"/>
              <a:stretch/>
            </p:blipFill>
            <p:spPr>
              <a:xfrm>
                <a:off x="5769283" y="3157837"/>
                <a:ext cx="2231687" cy="2133377"/>
              </a:xfrm>
              <a:prstGeom prst="rect">
                <a:avLst/>
              </a:prstGeom>
            </p:spPr>
          </p:pic>
          <p:sp>
            <p:nvSpPr>
              <p:cNvPr id="28" name="Textfeld 27">
                <a:extLst>
                  <a:ext uri="{FF2B5EF4-FFF2-40B4-BE49-F238E27FC236}">
                    <a16:creationId xmlns:a16="http://schemas.microsoft.com/office/drawing/2014/main" id="{53DA8107-7724-4F31-B17F-E7D000610D96}"/>
                  </a:ext>
                </a:extLst>
              </p:cNvPr>
              <p:cNvSpPr txBox="1"/>
              <p:nvPr/>
            </p:nvSpPr>
            <p:spPr>
              <a:xfrm>
                <a:off x="6762728" y="5263572"/>
                <a:ext cx="391454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de-DE" sz="1100" b="1" dirty="0"/>
                  <a:t>FSC</a:t>
                </a:r>
                <a:endParaRPr lang="en-US" sz="1100" b="1" dirty="0"/>
              </a:p>
            </p:txBody>
          </p:sp>
          <p:sp>
            <p:nvSpPr>
              <p:cNvPr id="32" name="Textfeld 31">
                <a:extLst>
                  <a:ext uri="{FF2B5EF4-FFF2-40B4-BE49-F238E27FC236}">
                    <a16:creationId xmlns:a16="http://schemas.microsoft.com/office/drawing/2014/main" id="{EA4EE916-9207-4B59-8E6E-5993E05C7B93}"/>
                  </a:ext>
                </a:extLst>
              </p:cNvPr>
              <p:cNvSpPr txBox="1"/>
              <p:nvPr/>
            </p:nvSpPr>
            <p:spPr>
              <a:xfrm>
                <a:off x="6776310" y="3220658"/>
                <a:ext cx="1140466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>
                    <a:solidFill>
                      <a:srgbClr val="0000FF"/>
                    </a:solidFill>
                  </a:rPr>
                  <a:t>Positive: 78.7%</a:t>
                </a:r>
                <a:endParaRPr lang="en-US" sz="1100" dirty="0">
                  <a:solidFill>
                    <a:srgbClr val="0000FF"/>
                  </a:solidFill>
                </a:endParaRPr>
              </a:p>
            </p:txBody>
          </p:sp>
          <p:sp>
            <p:nvSpPr>
              <p:cNvPr id="38" name="Textfeld 37">
                <a:extLst>
                  <a:ext uri="{FF2B5EF4-FFF2-40B4-BE49-F238E27FC236}">
                    <a16:creationId xmlns:a16="http://schemas.microsoft.com/office/drawing/2014/main" id="{D6A3EDE9-B4A7-46E8-8D6D-09892139BC89}"/>
                  </a:ext>
                </a:extLst>
              </p:cNvPr>
              <p:cNvSpPr txBox="1"/>
              <p:nvPr/>
            </p:nvSpPr>
            <p:spPr>
              <a:xfrm rot="16200000">
                <a:off x="4867107" y="4126031"/>
                <a:ext cx="1611440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/>
                  <a:t>Fluorescence intensity</a:t>
                </a:r>
              </a:p>
            </p:txBody>
          </p:sp>
          <p:sp>
            <p:nvSpPr>
              <p:cNvPr id="27" name="Textfeld 26">
                <a:extLst>
                  <a:ext uri="{FF2B5EF4-FFF2-40B4-BE49-F238E27FC236}">
                    <a16:creationId xmlns:a16="http://schemas.microsoft.com/office/drawing/2014/main" id="{C08F3355-0F2E-4A43-86F4-5298520DBC71}"/>
                  </a:ext>
                </a:extLst>
              </p:cNvPr>
              <p:cNvSpPr txBox="1"/>
              <p:nvPr/>
            </p:nvSpPr>
            <p:spPr>
              <a:xfrm>
                <a:off x="5922940" y="2977650"/>
                <a:ext cx="2057059" cy="19655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100" b="1" dirty="0"/>
                  <a:t>CD63</a:t>
                </a:r>
                <a:endParaRPr lang="en-US" sz="1100" b="1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1896563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9</Words>
  <Application>Microsoft Office PowerPoint</Application>
  <PresentationFormat>Breitbild</PresentationFormat>
  <Paragraphs>2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Zitta, Karina Silvana</dc:creator>
  <cp:lastModifiedBy>Albrecht, Martin</cp:lastModifiedBy>
  <cp:revision>25</cp:revision>
  <cp:lastPrinted>2022-09-06T08:00:10Z</cp:lastPrinted>
  <dcterms:created xsi:type="dcterms:W3CDTF">2022-09-05T11:54:42Z</dcterms:created>
  <dcterms:modified xsi:type="dcterms:W3CDTF">2022-09-09T12:54:04Z</dcterms:modified>
</cp:coreProperties>
</file>